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8" r:id="rId3"/>
    <p:sldId id="260" r:id="rId4"/>
    <p:sldId id="259" r:id="rId5"/>
  </p:sldIdLst>
  <p:sldSz cx="9144000" cy="5143500" type="screen16x9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18" d="100"/>
          <a:sy n="118" d="100"/>
        </p:scale>
        <p:origin x="96" y="34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355F7A-58C9-4E2E-A5EB-3812461B98E2}" type="datetimeFigureOut">
              <a:rPr lang="de-DE" smtClean="0"/>
              <a:t>03.08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E69176-B1A0-4022-BB2C-9D4DA3CD5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28441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b="1" dirty="0" err="1"/>
              <a:t>Figure</a:t>
            </a:r>
            <a:r>
              <a:rPr lang="de-DE" b="1" dirty="0"/>
              <a:t> S1. Impact </a:t>
            </a:r>
            <a:r>
              <a:rPr lang="de-DE" b="1" dirty="0" err="1"/>
              <a:t>of</a:t>
            </a:r>
            <a:r>
              <a:rPr lang="de-DE" b="1" dirty="0"/>
              <a:t> multiple </a:t>
            </a:r>
            <a:r>
              <a:rPr lang="de-DE" b="1" dirty="0" err="1"/>
              <a:t>gestation</a:t>
            </a:r>
            <a:r>
              <a:rPr lang="de-DE" b="1" dirty="0"/>
              <a:t> </a:t>
            </a:r>
            <a:r>
              <a:rPr lang="de-DE" b="1" dirty="0" err="1"/>
              <a:t>and</a:t>
            </a:r>
            <a:r>
              <a:rPr lang="de-DE" b="1" dirty="0"/>
              <a:t> </a:t>
            </a:r>
            <a:r>
              <a:rPr lang="de-DE" b="1" dirty="0" err="1"/>
              <a:t>interaction</a:t>
            </a:r>
            <a:r>
              <a:rPr lang="de-DE" b="1" dirty="0"/>
              <a:t> </a:t>
            </a:r>
            <a:r>
              <a:rPr lang="de-DE" b="1" dirty="0" err="1"/>
              <a:t>with</a:t>
            </a:r>
            <a:r>
              <a:rPr lang="de-DE" b="1" dirty="0"/>
              <a:t> </a:t>
            </a:r>
            <a:r>
              <a:rPr lang="de-DE" b="1" dirty="0" err="1"/>
              <a:t>the</a:t>
            </a:r>
            <a:r>
              <a:rPr lang="de-DE" b="1" dirty="0"/>
              <a:t> CXCL10 / CCL 2 </a:t>
            </a:r>
            <a:r>
              <a:rPr lang="de-DE" b="1" dirty="0" err="1"/>
              <a:t>ratio</a:t>
            </a:r>
            <a:r>
              <a:rPr lang="de-DE" b="1" dirty="0"/>
              <a:t>. A</a:t>
            </a:r>
            <a:r>
              <a:rPr lang="de-DE" dirty="0"/>
              <a:t> Boxplot </a:t>
            </a:r>
            <a:r>
              <a:rPr lang="de-DE" dirty="0" err="1"/>
              <a:t>comparing</a:t>
            </a:r>
            <a:r>
              <a:rPr lang="de-DE" dirty="0"/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XCL10 / CCL 2 ratio in dependence of gestation age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delivery (grouped) in dependence of multiple gestation. Similar correlation appeared in both subgroups. 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file plot of marginal means of CXCL10 / CCL 2 ratio by multiple gestation. The relative values in the mean CXCL10 / CCL 2 ratio between groups defined according to multiple gestation are the same for all groups of gestational age at delivery (main effect multiple gestation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 =0.78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Differences between the ratio mainly results from gestational age at delivery (main effect gestational age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 &lt;0.00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There is no interaction between multiple gestation (yes/no) and gestational age at delivery (effect of interaction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 =0.864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Analysis by two-factorial ANOVA. </a:t>
            </a:r>
            <a:endParaRPr lang="de-DE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F29E6D-88B6-4DEB-A584-527F32DCFE54}" type="slidenum">
              <a:rPr lang="de-DE" smtClean="0">
                <a:solidFill>
                  <a:prstClr val="black"/>
                </a:solidFill>
              </a:rPr>
              <a:pPr/>
              <a:t>1</a:t>
            </a:fld>
            <a:endParaRPr lang="de-DE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29390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b="1" dirty="0" err="1"/>
              <a:t>Figure</a:t>
            </a:r>
            <a:r>
              <a:rPr lang="de-DE" b="1" dirty="0"/>
              <a:t> S2. Boxplot </a:t>
            </a:r>
            <a:r>
              <a:rPr lang="de-DE" b="1" dirty="0" err="1"/>
              <a:t>of</a:t>
            </a:r>
            <a:r>
              <a:rPr lang="de-DE" b="1" dirty="0"/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XCL10 / CCL 2 ratio in dependence</a:t>
            </a:r>
            <a:r>
              <a:rPr lang="en-US" sz="1200" b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gestational age at delivery (grouped) and singleton pregnancies.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ruskal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Wallis analysis revealed significant differences between groups (p &lt; 0.001). 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F29E6D-88B6-4DEB-A584-527F32DCFE54}" type="slidenum">
              <a:rPr lang="de-DE" smtClean="0">
                <a:solidFill>
                  <a:prstClr val="black"/>
                </a:solidFill>
              </a:rPr>
              <a:pPr/>
              <a:t>2</a:t>
            </a:fld>
            <a:endParaRPr lang="de-DE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97170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45048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6368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543676" y="273844"/>
            <a:ext cx="1971675" cy="4358879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628651" y="273844"/>
            <a:ext cx="5800725" cy="4358879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5240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7633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3888" y="1282305"/>
            <a:ext cx="7886700" cy="213955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3888" y="3442099"/>
            <a:ext cx="7886700" cy="1125140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89894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2095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273845"/>
            <a:ext cx="7886700" cy="994172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29151" y="1260872"/>
            <a:ext cx="3887391" cy="617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29151" y="1878806"/>
            <a:ext cx="3887391" cy="2763441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73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9169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05213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87391" y="740570"/>
            <a:ext cx="4629150" cy="365521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1757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3887391" y="740570"/>
            <a:ext cx="4629150" cy="3655219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5961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628650" y="273845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628650" y="4767264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0713E2-336F-430F-9800-D78970A40920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03.08.2023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028950" y="4767264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457950" y="4767264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A0040-470A-4320-A427-9E300E48AE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79937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53C9463A-7A31-23BA-B5A0-5A94096B57EA}"/>
              </a:ext>
            </a:extLst>
          </p:cNvPr>
          <p:cNvGrpSpPr/>
          <p:nvPr/>
        </p:nvGrpSpPr>
        <p:grpSpPr>
          <a:xfrm>
            <a:off x="293073" y="271075"/>
            <a:ext cx="8557857" cy="3738950"/>
            <a:chOff x="390762" y="361434"/>
            <a:chExt cx="11410476" cy="4985266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422"/>
            <a:stretch/>
          </p:blipFill>
          <p:spPr bwMode="auto">
            <a:xfrm>
              <a:off x="390762" y="546100"/>
              <a:ext cx="5356895" cy="4800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435"/>
            <a:stretch/>
          </p:blipFill>
          <p:spPr bwMode="auto">
            <a:xfrm>
              <a:off x="5771364" y="693443"/>
              <a:ext cx="6029874" cy="45879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feld 1"/>
            <p:cNvSpPr txBox="1"/>
            <p:nvPr/>
          </p:nvSpPr>
          <p:spPr>
            <a:xfrm>
              <a:off x="390762" y="361434"/>
              <a:ext cx="351379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6048267" y="361434"/>
              <a:ext cx="468504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4" name="Rechteck 3"/>
          <p:cNvSpPr/>
          <p:nvPr/>
        </p:nvSpPr>
        <p:spPr>
          <a:xfrm>
            <a:off x="179512" y="3939902"/>
            <a:ext cx="8784976" cy="11711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ea typeface="Calibri"/>
                <a:cs typeface="Times New Roman"/>
              </a:rPr>
              <a:t>Figure S1. Impact of multiple gestation and interaction with the CXCL10 / CCL 2 ratio. A </a:t>
            </a:r>
            <a:r>
              <a:rPr lang="en-US" sz="1100" dirty="0">
                <a:ea typeface="Calibri"/>
                <a:cs typeface="Times New Roman"/>
              </a:rPr>
              <a:t>Boxplot comparing the CXCL10 / CCL2 ratio in dependence of gestational age at delivery (grouped) in dependence of multiple gestation. Similar correlation appeared in both subgroups. </a:t>
            </a:r>
            <a:r>
              <a:rPr lang="en-US" sz="1100" b="1" dirty="0">
                <a:ea typeface="Calibri"/>
                <a:cs typeface="Times New Roman"/>
              </a:rPr>
              <a:t>B</a:t>
            </a:r>
            <a:r>
              <a:rPr lang="en-US" sz="1100" dirty="0">
                <a:ea typeface="Calibri"/>
                <a:cs typeface="Times New Roman"/>
              </a:rPr>
              <a:t> Profile plot of marginal means of CXCL10 / CCL2 ratio by multiple gestation. The relative values of the mean CXCL10 / CCL2 ratio between groups defined according to multiple gestation are the same for all groups of gestational age at delivery (main effect multiple gestation P=0.781). Differences of the CXCL10 / CCL2 mainly results from gestational age at delivery (main effect gestational age P&lt;0.001). There is no interaction between multiple gestation (yes/no) and gestational age at delivery (effect of interaction P=0.864). Analysis by two-factorial ANOVA</a:t>
            </a:r>
            <a:r>
              <a:rPr lang="en-US" sz="1100" dirty="0" smtClean="0">
                <a:ea typeface="Calibri"/>
                <a:cs typeface="Times New Roman"/>
              </a:rPr>
              <a:t>.</a:t>
            </a:r>
            <a:endParaRPr lang="de-DE" sz="105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5190536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0693" y="511505"/>
            <a:ext cx="3643313" cy="3929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hteck 1"/>
          <p:cNvSpPr/>
          <p:nvPr/>
        </p:nvSpPr>
        <p:spPr>
          <a:xfrm>
            <a:off x="359532" y="4431693"/>
            <a:ext cx="8424936" cy="4788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ea typeface="Calibri"/>
                <a:cs typeface="Times New Roman"/>
              </a:rPr>
              <a:t>Figure S2. Boxplot of CXCL10 / CCL 2 ratio in dependence of gestational age at delivery (grouped) and singleton pregnancies.</a:t>
            </a:r>
            <a:r>
              <a:rPr lang="en-US" sz="1200" dirty="0" smtClean="0">
                <a:ea typeface="Calibri"/>
                <a:cs typeface="Times New Roman"/>
              </a:rPr>
              <a:t> </a:t>
            </a:r>
            <a:r>
              <a:rPr lang="en-US" sz="1200" dirty="0" err="1" smtClean="0">
                <a:ea typeface="Calibri"/>
                <a:cs typeface="Times New Roman"/>
              </a:rPr>
              <a:t>Kruskal</a:t>
            </a:r>
            <a:r>
              <a:rPr lang="en-US" sz="1200" dirty="0" smtClean="0">
                <a:ea typeface="Calibri"/>
                <a:cs typeface="Times New Roman"/>
              </a:rPr>
              <a:t>-Wallis analysis revealed significant differences between groups (p&lt; 0.001).</a:t>
            </a:r>
            <a:endParaRPr lang="de-DE" sz="1100" dirty="0"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2072725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323528" y="4023823"/>
            <a:ext cx="8424936" cy="685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ea typeface="Calibri"/>
                <a:cs typeface="Times New Roman"/>
              </a:rPr>
              <a:t>Figure </a:t>
            </a:r>
            <a:r>
              <a:rPr lang="en-US" sz="1200" b="1" dirty="0" smtClean="0">
                <a:ea typeface="Calibri"/>
                <a:cs typeface="Times New Roman"/>
              </a:rPr>
              <a:t>S3</a:t>
            </a:r>
            <a:r>
              <a:rPr lang="en-US" sz="1200" b="1" dirty="0">
                <a:ea typeface="Calibri"/>
                <a:cs typeface="Times New Roman"/>
              </a:rPr>
              <a:t>. Receiver operating characteristics (ROC) curves for the prediction of spontaneous preterm </a:t>
            </a:r>
            <a:r>
              <a:rPr lang="en-US" sz="1200" b="1" dirty="0" smtClean="0">
                <a:ea typeface="Calibri"/>
                <a:cs typeface="Times New Roman"/>
              </a:rPr>
              <a:t>birth &lt;34 weeks </a:t>
            </a:r>
            <a:r>
              <a:rPr lang="en-US" sz="1200" b="1" dirty="0">
                <a:ea typeface="Calibri"/>
                <a:cs typeface="Times New Roman"/>
              </a:rPr>
              <a:t>in symptomatic </a:t>
            </a:r>
            <a:r>
              <a:rPr lang="en-US" sz="1200" b="1" dirty="0" smtClean="0">
                <a:ea typeface="Calibri"/>
                <a:cs typeface="Times New Roman"/>
              </a:rPr>
              <a:t>women. </a:t>
            </a:r>
            <a:r>
              <a:rPr lang="en-US" sz="1200" dirty="0" smtClean="0">
                <a:ea typeface="Calibri"/>
                <a:cs typeface="Times New Roman"/>
              </a:rPr>
              <a:t>Comparison of </a:t>
            </a:r>
            <a:r>
              <a:rPr lang="en-US" sz="1200" dirty="0" smtClean="0">
                <a:ea typeface="Calibri"/>
                <a:cs typeface="Times New Roman"/>
              </a:rPr>
              <a:t>CXCL10 </a:t>
            </a:r>
            <a:r>
              <a:rPr lang="en-US" sz="1200" dirty="0" smtClean="0">
                <a:ea typeface="Calibri"/>
                <a:cs typeface="Times New Roman"/>
              </a:rPr>
              <a:t>/ CCL 2 </a:t>
            </a:r>
            <a:r>
              <a:rPr lang="en-US" sz="1200" dirty="0">
                <a:ea typeface="Calibri"/>
                <a:cs typeface="Times New Roman"/>
              </a:rPr>
              <a:t>ratio </a:t>
            </a:r>
            <a:r>
              <a:rPr lang="en-US" sz="1200" dirty="0" smtClean="0">
                <a:ea typeface="Calibri"/>
                <a:cs typeface="Times New Roman"/>
              </a:rPr>
              <a:t>alone (blue line, </a:t>
            </a:r>
            <a:r>
              <a:rPr lang="en-US" sz="1200" smtClean="0">
                <a:ea typeface="Calibri"/>
                <a:cs typeface="Times New Roman"/>
              </a:rPr>
              <a:t>AUC 0.83) </a:t>
            </a:r>
            <a:r>
              <a:rPr lang="en-US" sz="1200" dirty="0" smtClean="0">
                <a:ea typeface="Calibri"/>
                <a:cs typeface="Times New Roman"/>
              </a:rPr>
              <a:t>and the combination with cervical length (predictive probability by logistic regression, green line, AUC 0.84) with an </a:t>
            </a:r>
            <a:r>
              <a:rPr lang="en-US" sz="1200" dirty="0">
                <a:ea typeface="Calibri"/>
                <a:cs typeface="Times New Roman"/>
              </a:rPr>
              <a:t>AUC-difference </a:t>
            </a:r>
            <a:r>
              <a:rPr lang="en-US" sz="1200" dirty="0" smtClean="0">
                <a:ea typeface="Calibri"/>
                <a:cs typeface="Times New Roman"/>
              </a:rPr>
              <a:t>of -0.015 </a:t>
            </a:r>
            <a:r>
              <a:rPr lang="en-US" sz="1200" dirty="0">
                <a:ea typeface="Calibri"/>
                <a:cs typeface="Times New Roman"/>
              </a:rPr>
              <a:t>(-0.103-0.73), p = 0.734</a:t>
            </a:r>
            <a:endParaRPr lang="de-DE" sz="1100" dirty="0">
              <a:ea typeface="Calibri"/>
              <a:cs typeface="Times New Roman"/>
            </a:endParaRPr>
          </a:p>
        </p:txBody>
      </p:sp>
      <p:grpSp>
        <p:nvGrpSpPr>
          <p:cNvPr id="7" name="Gruppieren 6"/>
          <p:cNvGrpSpPr/>
          <p:nvPr/>
        </p:nvGrpSpPr>
        <p:grpSpPr>
          <a:xfrm>
            <a:off x="453380" y="123478"/>
            <a:ext cx="4838700" cy="3888432"/>
            <a:chOff x="539552" y="411510"/>
            <a:chExt cx="4838700" cy="3888432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2"/>
            <a:srcRect t="5355" b="14283"/>
            <a:stretch/>
          </p:blipFill>
          <p:spPr>
            <a:xfrm>
              <a:off x="539552" y="411510"/>
              <a:ext cx="4838700" cy="3888432"/>
            </a:xfrm>
            <a:prstGeom prst="rect">
              <a:avLst/>
            </a:prstGeom>
          </p:spPr>
        </p:pic>
        <p:sp>
          <p:nvSpPr>
            <p:cNvPr id="5" name="Textfeld 2"/>
            <p:cNvSpPr txBox="1"/>
            <p:nvPr/>
          </p:nvSpPr>
          <p:spPr>
            <a:xfrm>
              <a:off x="3882708" y="1131590"/>
              <a:ext cx="1378583" cy="609013"/>
            </a:xfrm>
            <a:prstGeom prst="rect">
              <a:avLst/>
            </a:prstGeom>
            <a:solidFill>
              <a:schemeClr val="bg1"/>
            </a:solidFill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100"/>
                <a:t>CXCL10/CCL2 Ratio</a:t>
              </a:r>
            </a:p>
            <a:p>
              <a:r>
                <a:rPr lang="de-DE" sz="1100"/>
                <a:t>CXCL10/CCL2 Ratio +</a:t>
              </a:r>
              <a:br>
                <a:rPr lang="de-DE" sz="1100"/>
              </a:br>
              <a:r>
                <a:rPr lang="de-DE" sz="1100"/>
                <a:t>Cervical length</a:t>
              </a:r>
            </a:p>
          </p:txBody>
        </p:sp>
        <p:sp>
          <p:nvSpPr>
            <p:cNvPr id="6" name="Textfeld 3"/>
            <p:cNvSpPr txBox="1"/>
            <p:nvPr/>
          </p:nvSpPr>
          <p:spPr>
            <a:xfrm>
              <a:off x="3816033" y="2150765"/>
              <a:ext cx="1324530" cy="609013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de-DE" sz="1100"/>
                <a:t>AUC-difference:</a:t>
              </a:r>
            </a:p>
            <a:p>
              <a:r>
                <a:rPr lang="de-DE" sz="1100"/>
                <a:t>-0.015 (-0.103-0.73)</a:t>
              </a:r>
              <a:br>
                <a:rPr lang="de-DE" sz="1100"/>
              </a:br>
              <a:r>
                <a:rPr lang="de-DE" sz="1100"/>
                <a:t>p</a:t>
              </a:r>
              <a:r>
                <a:rPr lang="de-DE" sz="1100" baseline="0"/>
                <a:t> = 0.734</a:t>
              </a:r>
              <a:endParaRPr lang="de-DE" sz="1100"/>
            </a:p>
          </p:txBody>
        </p:sp>
      </p:grpSp>
    </p:spTree>
    <p:extLst>
      <p:ext uri="{BB962C8B-B14F-4D97-AF65-F5344CB8AC3E}">
        <p14:creationId xmlns:p14="http://schemas.microsoft.com/office/powerpoint/2010/main" val="5811577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179512" y="739606"/>
            <a:ext cx="5256584" cy="34163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Table S1</a:t>
            </a:r>
            <a:r>
              <a:rPr kumimoji="0" lang="en-US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. Characteristics of the used ELISAs.</a:t>
            </a:r>
            <a:endParaRPr kumimoji="0" lang="de-DE" alt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de-DE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de-DE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de-DE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de-DE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de-DE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de-DE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de-DE" sz="1200" dirty="0">
              <a:latin typeface="Calibri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CV = coefficient of variation</a:t>
            </a:r>
            <a:endParaRPr kumimoji="0" lang="en-US" altLang="de-DE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/>
            </a:r>
            <a:br>
              <a:rPr kumimoji="0" lang="en-US" altLang="de-D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</a:br>
            <a:endParaRPr kumimoji="0" lang="de-DE" altLang="de-DE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9690064"/>
              </p:ext>
            </p:extLst>
          </p:nvPr>
        </p:nvGraphicFramePr>
        <p:xfrm>
          <a:off x="251520" y="1059582"/>
          <a:ext cx="5761990" cy="2152651"/>
        </p:xfrm>
        <a:graphic>
          <a:graphicData uri="http://schemas.openxmlformats.org/drawingml/2006/table">
            <a:tbl>
              <a:tblPr firstRow="1" firstCol="1" bandRow="1"/>
              <a:tblGrid>
                <a:gridCol w="10769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04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1026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7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8679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ssay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Company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Catalog number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Detection rang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Intra-assay CV for mean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Inter-assay CV for mean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Minimum detection dose (sensitivity)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CXCL10 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(Human IP-10)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BOSTER biological technology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EK0735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31.2 – 2000 </a:t>
                      </a:r>
                      <a:r>
                        <a:rPr lang="en-GB" sz="11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pg</a:t>
                      </a:r>
                      <a:r>
                        <a:rPr lang="en-GB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/mL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8 %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10 %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1 pg/mL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CCL2 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(Human MCP-1)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BOSTER biological technology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EK0441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15.6 - 1000 pg/mL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8 %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8 %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1 pg/mL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Serpin B7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MyBioSource 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MBS2610991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0.312 - 20 ng/mL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8 %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effectLst/>
                          <a:latin typeface="Calibri"/>
                          <a:ea typeface="Calibri"/>
                          <a:cs typeface="Times New Roman"/>
                        </a:rPr>
                        <a:t>&lt;12 %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0.06 ng/mL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2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87516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4</Words>
  <Application>Microsoft Office PowerPoint</Application>
  <PresentationFormat>Bildschirmpräsentation (16:9)</PresentationFormat>
  <Paragraphs>59</Paragraphs>
  <Slides>4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nes Stubert</dc:creator>
  <cp:lastModifiedBy>Prof. Dr. J. Stubert</cp:lastModifiedBy>
  <cp:revision>4</cp:revision>
  <dcterms:created xsi:type="dcterms:W3CDTF">2023-04-02T16:04:17Z</dcterms:created>
  <dcterms:modified xsi:type="dcterms:W3CDTF">2023-08-03T10:32:05Z</dcterms:modified>
</cp:coreProperties>
</file>